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-1109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plastische-chirurgie\data\AG_Lipotransfer_Weigand\Studie%20ADSC%20HMEC\Ergebnisse\EC%20Differenzierung\zur%20Auswertung\Tube%20formation%20results_ADSC%20EC-Diff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plastische-chirurgie\data\AG_Lipotransfer_Weigand\Studie%20ADSC%20HMEC\Ergebnisse\EC%20Differenzierung\zur%20Auswertung\Tube%20formation%20results_ADSC%20EC-Diff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edads.uk-erlangen.de\fileservice\plastische-chirurgie\data\AG_Lipotransfer_Weigand\Studie%20ADSC%20HMEC\Ergebnisse\EC%20Differenzierung\zur%20Auswertung\Tube%20formation%20results_ADSC%20EC-Diff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J$2</c:f>
              <c:strCache>
                <c:ptCount val="1"/>
                <c:pt idx="0">
                  <c:v>1w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J$9:$J$13</c:f>
                <c:numCache>
                  <c:formatCode>General</c:formatCode>
                  <c:ptCount val="5"/>
                  <c:pt idx="0">
                    <c:v>3.85903250226094</c:v>
                  </c:pt>
                  <c:pt idx="1">
                    <c:v>9.1565872275595641</c:v>
                  </c:pt>
                  <c:pt idx="2">
                    <c:v>4.9524208505280898</c:v>
                  </c:pt>
                  <c:pt idx="4">
                    <c:v>2.6437836792949492</c:v>
                  </c:pt>
                </c:numCache>
              </c:numRef>
            </c:plus>
            <c:minus>
              <c:numRef>
                <c:f>Tabelle1!$J$9:$J$13</c:f>
                <c:numCache>
                  <c:formatCode>General</c:formatCode>
                  <c:ptCount val="5"/>
                  <c:pt idx="0">
                    <c:v>3.85903250226094</c:v>
                  </c:pt>
                  <c:pt idx="1">
                    <c:v>9.1565872275595641</c:v>
                  </c:pt>
                  <c:pt idx="2">
                    <c:v>4.9524208505280898</c:v>
                  </c:pt>
                  <c:pt idx="4">
                    <c:v>2.6437836792949492</c:v>
                  </c:pt>
                </c:numCache>
              </c:numRef>
            </c:minus>
          </c:errBars>
          <c:cat>
            <c:strRef>
              <c:f>Tabelle1!$I$3:$I$5</c:f>
              <c:strCache>
                <c:ptCount val="3"/>
                <c:pt idx="0">
                  <c:v>TRIDUC1</c:v>
                </c:pt>
                <c:pt idx="1">
                  <c:v>IFDUC1</c:v>
                </c:pt>
                <c:pt idx="2">
                  <c:v>NORMA4</c:v>
                </c:pt>
              </c:strCache>
            </c:strRef>
          </c:cat>
          <c:val>
            <c:numRef>
              <c:f>Tabelle1!$J$3:$J$5</c:f>
              <c:numCache>
                <c:formatCode>General</c:formatCode>
                <c:ptCount val="3"/>
                <c:pt idx="0">
                  <c:v>89.43530633333333</c:v>
                </c:pt>
                <c:pt idx="1">
                  <c:v>79.486777999999987</c:v>
                </c:pt>
                <c:pt idx="2">
                  <c:v>79.4465833333333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051008"/>
        <c:axId val="81074816"/>
      </c:barChart>
      <c:catAx>
        <c:axId val="81051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1074816"/>
        <c:crosses val="autoZero"/>
        <c:auto val="1"/>
        <c:lblAlgn val="ctr"/>
        <c:lblOffset val="100"/>
        <c:noMultiLvlLbl val="0"/>
      </c:catAx>
      <c:valAx>
        <c:axId val="8107481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mm</a:t>
                </a:r>
              </a:p>
            </c:rich>
          </c:tx>
          <c:layout>
            <c:manualLayout>
              <c:xMode val="edge"/>
              <c:yMode val="edge"/>
              <c:x val="7.4530516431924876E-2"/>
              <c:y val="0.3427717482702287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810510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J$16</c:f>
              <c:strCache>
                <c:ptCount val="1"/>
                <c:pt idx="0">
                  <c:v>1w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J$23:$J$27</c:f>
                <c:numCache>
                  <c:formatCode>General</c:formatCode>
                  <c:ptCount val="5"/>
                  <c:pt idx="0">
                    <c:v>0.50547168231916451</c:v>
                  </c:pt>
                  <c:pt idx="1">
                    <c:v>0.26920957105372312</c:v>
                  </c:pt>
                  <c:pt idx="2">
                    <c:v>0.34103610391675243</c:v>
                  </c:pt>
                  <c:pt idx="4">
                    <c:v>0.22476958842101055</c:v>
                  </c:pt>
                </c:numCache>
              </c:numRef>
            </c:plus>
            <c:minus>
              <c:numRef>
                <c:f>Tabelle1!$J$23:$J$27</c:f>
                <c:numCache>
                  <c:formatCode>General</c:formatCode>
                  <c:ptCount val="5"/>
                  <c:pt idx="0">
                    <c:v>0.50547168231916451</c:v>
                  </c:pt>
                  <c:pt idx="1">
                    <c:v>0.26920957105372312</c:v>
                  </c:pt>
                  <c:pt idx="2">
                    <c:v>0.34103610391675243</c:v>
                  </c:pt>
                  <c:pt idx="4">
                    <c:v>0.22476958842101055</c:v>
                  </c:pt>
                </c:numCache>
              </c:numRef>
            </c:minus>
          </c:errBars>
          <c:cat>
            <c:strRef>
              <c:f>Tabelle1!$I$17:$I$19</c:f>
              <c:strCache>
                <c:ptCount val="3"/>
                <c:pt idx="0">
                  <c:v>TRIDUC1</c:v>
                </c:pt>
                <c:pt idx="1">
                  <c:v>IFDUC1</c:v>
                </c:pt>
                <c:pt idx="2">
                  <c:v>NORMA4</c:v>
                </c:pt>
              </c:strCache>
            </c:strRef>
          </c:cat>
          <c:val>
            <c:numRef>
              <c:f>Tabelle1!$J$17:$J$19</c:f>
              <c:numCache>
                <c:formatCode>General</c:formatCode>
                <c:ptCount val="3"/>
                <c:pt idx="0">
                  <c:v>4.4420648349118634</c:v>
                </c:pt>
                <c:pt idx="1">
                  <c:v>4.6274725940950967</c:v>
                </c:pt>
                <c:pt idx="2">
                  <c:v>6.17078919628768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1037056"/>
        <c:axId val="126994688"/>
      </c:barChart>
      <c:catAx>
        <c:axId val="91037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26994688"/>
        <c:crosses val="autoZero"/>
        <c:auto val="1"/>
        <c:lblAlgn val="ctr"/>
        <c:lblOffset val="100"/>
        <c:noMultiLvlLbl val="0"/>
      </c:catAx>
      <c:valAx>
        <c:axId val="1269946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mm²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10370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77777777777777"/>
          <c:y val="0.23694154314086929"/>
          <c:w val="0.78152136752136747"/>
          <c:h val="0.582257623667210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J$30</c:f>
              <c:strCache>
                <c:ptCount val="1"/>
                <c:pt idx="0">
                  <c:v>1w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Tabelle1!$J$37:$J$41</c:f>
                <c:numCache>
                  <c:formatCode>General</c:formatCode>
                  <c:ptCount val="5"/>
                  <c:pt idx="0">
                    <c:v>9.0737717258774655</c:v>
                  </c:pt>
                  <c:pt idx="1">
                    <c:v>31.817186131607173</c:v>
                  </c:pt>
                  <c:pt idx="2">
                    <c:v>25.159491250818249</c:v>
                  </c:pt>
                  <c:pt idx="4">
                    <c:v>5.6862407030773268</c:v>
                  </c:pt>
                </c:numCache>
              </c:numRef>
            </c:plus>
            <c:minus>
              <c:numRef>
                <c:f>Tabelle1!$J$37:$J$41</c:f>
                <c:numCache>
                  <c:formatCode>General</c:formatCode>
                  <c:ptCount val="5"/>
                  <c:pt idx="0">
                    <c:v>9.0737717258774655</c:v>
                  </c:pt>
                  <c:pt idx="1">
                    <c:v>31.817186131607173</c:v>
                  </c:pt>
                  <c:pt idx="2">
                    <c:v>25.159491250818249</c:v>
                  </c:pt>
                  <c:pt idx="4">
                    <c:v>5.6862407030773268</c:v>
                  </c:pt>
                </c:numCache>
              </c:numRef>
            </c:minus>
          </c:errBars>
          <c:cat>
            <c:strRef>
              <c:f>Tabelle1!$I$31:$I$33</c:f>
              <c:strCache>
                <c:ptCount val="3"/>
                <c:pt idx="0">
                  <c:v>TRIDUC1</c:v>
                </c:pt>
                <c:pt idx="1">
                  <c:v>IFDUC1</c:v>
                </c:pt>
                <c:pt idx="2">
                  <c:v>NORMA4</c:v>
                </c:pt>
              </c:strCache>
            </c:strRef>
          </c:cat>
          <c:val>
            <c:numRef>
              <c:f>Tabelle1!$J$31:$J$33</c:f>
              <c:numCache>
                <c:formatCode>General</c:formatCode>
                <c:ptCount val="3"/>
                <c:pt idx="0">
                  <c:v>191.33333333333334</c:v>
                </c:pt>
                <c:pt idx="1">
                  <c:v>160.33333333333334</c:v>
                </c:pt>
                <c:pt idx="2">
                  <c:v>1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2154880"/>
        <c:axId val="172156800"/>
      </c:barChart>
      <c:catAx>
        <c:axId val="172154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72156800"/>
        <c:crosses val="autoZero"/>
        <c:auto val="1"/>
        <c:lblAlgn val="ctr"/>
        <c:lblOffset val="100"/>
        <c:noMultiLvlLbl val="0"/>
      </c:catAx>
      <c:valAx>
        <c:axId val="172156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721548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5382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8904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2688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3725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1460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269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3194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320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4314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9268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193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535AAE-5778-4AD3-B4DD-E7D29E18A283}" type="datetimeFigureOut">
              <a:rPr lang="de-DE" smtClean="0"/>
              <a:t>22.01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75AD9-A33E-4BD7-B4A7-4BFC9C66B5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114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95536" y="692696"/>
            <a:ext cx="7056784" cy="1547992"/>
            <a:chOff x="395536" y="692696"/>
            <a:chExt cx="7056784" cy="1547992"/>
          </a:xfrm>
        </p:grpSpPr>
        <p:graphicFrame>
          <p:nvGraphicFramePr>
            <p:cNvPr id="7" name="Diagramm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79548782"/>
                </p:ext>
              </p:extLst>
            </p:nvPr>
          </p:nvGraphicFramePr>
          <p:xfrm>
            <a:off x="395536" y="908720"/>
            <a:ext cx="2556000" cy="13319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Diagram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11660844"/>
                </p:ext>
              </p:extLst>
            </p:nvPr>
          </p:nvGraphicFramePr>
          <p:xfrm>
            <a:off x="5004320" y="908720"/>
            <a:ext cx="2448000" cy="13319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Diagramm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11598355"/>
                </p:ext>
              </p:extLst>
            </p:nvPr>
          </p:nvGraphicFramePr>
          <p:xfrm>
            <a:off x="2880072" y="692696"/>
            <a:ext cx="2340000" cy="15439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" name="Textfeld 9"/>
            <p:cNvSpPr txBox="1"/>
            <p:nvPr/>
          </p:nvSpPr>
          <p:spPr>
            <a:xfrm>
              <a:off x="899592" y="69269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be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ngth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580384" y="692696"/>
              <a:ext cx="12241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3203848" y="692696"/>
              <a:ext cx="13681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ops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539552" y="703729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5148064" y="703729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916392" y="703729"/>
              <a:ext cx="215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784377" y="847745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*</a:t>
              </a:r>
              <a:endParaRPr lang="de-DE" sz="1200" dirty="0"/>
            </a:p>
          </p:txBody>
        </p:sp>
        <p:cxnSp>
          <p:nvCxnSpPr>
            <p:cNvPr id="18" name="Gerade Verbindung 17"/>
            <p:cNvCxnSpPr/>
            <p:nvPr/>
          </p:nvCxnSpPr>
          <p:spPr>
            <a:xfrm>
              <a:off x="1296501" y="996449"/>
              <a:ext cx="122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18"/>
            <p:cNvCxnSpPr/>
            <p:nvPr/>
          </p:nvCxnSpPr>
          <p:spPr>
            <a:xfrm>
              <a:off x="1296061" y="996214"/>
              <a:ext cx="0" cy="7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19"/>
            <p:cNvCxnSpPr/>
            <p:nvPr/>
          </p:nvCxnSpPr>
          <p:spPr>
            <a:xfrm>
              <a:off x="2520149" y="992919"/>
              <a:ext cx="0" cy="14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feld 20"/>
            <p:cNvSpPr txBox="1"/>
            <p:nvPr/>
          </p:nvSpPr>
          <p:spPr>
            <a:xfrm>
              <a:off x="6263344" y="850064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*</a:t>
              </a:r>
              <a:endParaRPr lang="de-DE" sz="1200" dirty="0"/>
            </a:p>
          </p:txBody>
        </p:sp>
        <p:cxnSp>
          <p:nvCxnSpPr>
            <p:cNvPr id="22" name="Gerade Verbindung 21"/>
            <p:cNvCxnSpPr/>
            <p:nvPr/>
          </p:nvCxnSpPr>
          <p:spPr>
            <a:xfrm>
              <a:off x="5796528" y="998768"/>
              <a:ext cx="1195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 Verbindung 22"/>
            <p:cNvCxnSpPr/>
            <p:nvPr/>
          </p:nvCxnSpPr>
          <p:spPr>
            <a:xfrm>
              <a:off x="5796528" y="995238"/>
              <a:ext cx="0" cy="324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23"/>
            <p:cNvCxnSpPr/>
            <p:nvPr/>
          </p:nvCxnSpPr>
          <p:spPr>
            <a:xfrm>
              <a:off x="6999116" y="995238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6401408" y="1092290"/>
              <a:ext cx="5904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>
              <a:off x="6401408" y="1088760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feld 30"/>
            <p:cNvSpPr txBox="1"/>
            <p:nvPr/>
          </p:nvSpPr>
          <p:spPr>
            <a:xfrm>
              <a:off x="6588496" y="950260"/>
              <a:ext cx="3600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*</a:t>
              </a:r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85143088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Erlang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igand, Annika</dc:creator>
  <cp:lastModifiedBy>Weigand, Annika</cp:lastModifiedBy>
  <cp:revision>8</cp:revision>
  <dcterms:created xsi:type="dcterms:W3CDTF">2016-01-13T13:41:50Z</dcterms:created>
  <dcterms:modified xsi:type="dcterms:W3CDTF">2016-01-22T15:50:53Z</dcterms:modified>
</cp:coreProperties>
</file>